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  <p:sldId id="256" r:id="rId3"/>
    <p:sldId id="257" r:id="rId4"/>
    <p:sldId id="258" r:id="rId5"/>
    <p:sldId id="260" r:id="rId6"/>
    <p:sldId id="259" r:id="rId7"/>
    <p:sldId id="263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1" autoAdjust="0"/>
    <p:restoredTop sz="94660"/>
  </p:normalViewPr>
  <p:slideViewPr>
    <p:cSldViewPr snapToGrid="0">
      <p:cViewPr varScale="1">
        <p:scale>
          <a:sx n="48" d="100"/>
          <a:sy n="48" d="100"/>
        </p:scale>
        <p:origin x="730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121C3-BFA1-499D-B343-A89E476247AB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2D0A3-3E01-4F0A-B85C-1FAB36953E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5649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121C3-BFA1-499D-B343-A89E476247AB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2D0A3-3E01-4F0A-B85C-1FAB36953E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0375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121C3-BFA1-499D-B343-A89E476247AB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2D0A3-3E01-4F0A-B85C-1FAB36953E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555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121C3-BFA1-499D-B343-A89E476247AB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2D0A3-3E01-4F0A-B85C-1FAB36953E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9140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121C3-BFA1-499D-B343-A89E476247AB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2D0A3-3E01-4F0A-B85C-1FAB36953E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031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121C3-BFA1-499D-B343-A89E476247AB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2D0A3-3E01-4F0A-B85C-1FAB36953E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4070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121C3-BFA1-499D-B343-A89E476247AB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2D0A3-3E01-4F0A-B85C-1FAB36953E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5319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121C3-BFA1-499D-B343-A89E476247AB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2D0A3-3E01-4F0A-B85C-1FAB36953E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33505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121C3-BFA1-499D-B343-A89E476247AB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2D0A3-3E01-4F0A-B85C-1FAB36953E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6926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121C3-BFA1-499D-B343-A89E476247AB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2D0A3-3E01-4F0A-B85C-1FAB36953E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9018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121C3-BFA1-499D-B343-A89E476247AB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2D0A3-3E01-4F0A-B85C-1FAB36953E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9681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0121C3-BFA1-499D-B343-A89E476247AB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C2D0A3-3E01-4F0A-B85C-1FAB36953E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88031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图片 27">
            <a:extLst>
              <a:ext uri="{FF2B5EF4-FFF2-40B4-BE49-F238E27FC236}">
                <a16:creationId xmlns:a16="http://schemas.microsoft.com/office/drawing/2014/main" id="{A6E2FF08-B25A-20D6-71E2-B212C2459D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8248" y="2826583"/>
            <a:ext cx="3143571" cy="994576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03528C52-6077-C9F6-06E7-90B034A2CDA0}"/>
              </a:ext>
            </a:extLst>
          </p:cNvPr>
          <p:cNvSpPr/>
          <p:nvPr/>
        </p:nvSpPr>
        <p:spPr>
          <a:xfrm>
            <a:off x="514350" y="1163783"/>
            <a:ext cx="5829300" cy="26808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EC36AFB2-0814-D879-5481-66F25294A97C}"/>
              </a:ext>
            </a:extLst>
          </p:cNvPr>
          <p:cNvGrpSpPr/>
          <p:nvPr/>
        </p:nvGrpSpPr>
        <p:grpSpPr>
          <a:xfrm>
            <a:off x="1396336" y="1266702"/>
            <a:ext cx="3651410" cy="1472693"/>
            <a:chOff x="615731" y="1199542"/>
            <a:chExt cx="3291251" cy="1287766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0AB29BA1-FAE2-5F1C-37F4-47869494806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15731" y="1554687"/>
              <a:ext cx="3291251" cy="932621"/>
            </a:xfrm>
            <a:prstGeom prst="rect">
              <a:avLst/>
            </a:prstGeom>
          </p:spPr>
        </p:pic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0BA9E8FE-6523-18AB-943A-138450D9D44F}"/>
                </a:ext>
              </a:extLst>
            </p:cNvPr>
            <p:cNvSpPr txBox="1"/>
            <p:nvPr/>
          </p:nvSpPr>
          <p:spPr>
            <a:xfrm>
              <a:off x="2058275" y="1199542"/>
              <a:ext cx="13005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ATP6V0A2</a:t>
              </a:r>
              <a:endParaRPr lang="zh-CN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AEBF6996-318F-DE20-DF10-BBA954DFE711}"/>
                </a:ext>
              </a:extLst>
            </p:cNvPr>
            <p:cNvSpPr/>
            <p:nvPr/>
          </p:nvSpPr>
          <p:spPr>
            <a:xfrm>
              <a:off x="2535019" y="2058925"/>
              <a:ext cx="1045152" cy="26984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7" name="文本框 16">
            <a:extLst>
              <a:ext uri="{FF2B5EF4-FFF2-40B4-BE49-F238E27FC236}">
                <a16:creationId xmlns:a16="http://schemas.microsoft.com/office/drawing/2014/main" id="{833BBE82-AC1F-4FC0-B47B-7993452D8C3F}"/>
              </a:ext>
            </a:extLst>
          </p:cNvPr>
          <p:cNvSpPr txBox="1"/>
          <p:nvPr/>
        </p:nvSpPr>
        <p:spPr>
          <a:xfrm>
            <a:off x="3102688" y="2727274"/>
            <a:ext cx="903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A8FFC71E-0B66-F2C7-3BD2-5DD3A5F813E8}"/>
              </a:ext>
            </a:extLst>
          </p:cNvPr>
          <p:cNvSpPr txBox="1"/>
          <p:nvPr/>
        </p:nvSpPr>
        <p:spPr>
          <a:xfrm>
            <a:off x="514350" y="718251"/>
            <a:ext cx="36143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Full unedited gel for Figure1C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A909790B-2F16-34BE-EBD7-AE57D836B02F}"/>
              </a:ext>
            </a:extLst>
          </p:cNvPr>
          <p:cNvSpPr txBox="1"/>
          <p:nvPr/>
        </p:nvSpPr>
        <p:spPr>
          <a:xfrm>
            <a:off x="666749" y="1227223"/>
            <a:ext cx="4797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A4D29960-2B93-361A-CA05-6F6C8E1070B9}"/>
              </a:ext>
            </a:extLst>
          </p:cNvPr>
          <p:cNvSpPr/>
          <p:nvPr/>
        </p:nvSpPr>
        <p:spPr>
          <a:xfrm>
            <a:off x="3586372" y="3158322"/>
            <a:ext cx="1154863" cy="3827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箭头: 右 35">
            <a:extLst>
              <a:ext uri="{FF2B5EF4-FFF2-40B4-BE49-F238E27FC236}">
                <a16:creationId xmlns:a16="http://schemas.microsoft.com/office/drawing/2014/main" id="{D044DC6B-F7CB-1672-D344-33E213EE3C2F}"/>
              </a:ext>
            </a:extLst>
          </p:cNvPr>
          <p:cNvSpPr/>
          <p:nvPr/>
        </p:nvSpPr>
        <p:spPr>
          <a:xfrm flipH="1">
            <a:off x="4842922" y="3245398"/>
            <a:ext cx="341168" cy="164381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grpSp>
        <p:nvGrpSpPr>
          <p:cNvPr id="8" name="组合 7">
            <a:extLst>
              <a:ext uri="{FF2B5EF4-FFF2-40B4-BE49-F238E27FC236}">
                <a16:creationId xmlns:a16="http://schemas.microsoft.com/office/drawing/2014/main" id="{993F9352-29D0-C17D-0778-B3165F3C32F9}"/>
              </a:ext>
            </a:extLst>
          </p:cNvPr>
          <p:cNvGrpSpPr/>
          <p:nvPr/>
        </p:nvGrpSpPr>
        <p:grpSpPr>
          <a:xfrm>
            <a:off x="514350" y="4179470"/>
            <a:ext cx="5829300" cy="5320721"/>
            <a:chOff x="514350" y="4179470"/>
            <a:chExt cx="5829300" cy="5320721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0D855FAA-8E84-1A0E-1EA0-C8172A286F8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68287" y="5006347"/>
              <a:ext cx="2927415" cy="1319245"/>
            </a:xfrm>
            <a:prstGeom prst="rect">
              <a:avLst/>
            </a:prstGeom>
          </p:spPr>
        </p:pic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3E14610E-ACDD-37BD-837F-B2DE21511A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2399" t="16288" b="22117"/>
            <a:stretch/>
          </p:blipFill>
          <p:spPr>
            <a:xfrm>
              <a:off x="2189017" y="8645741"/>
              <a:ext cx="3103459" cy="763950"/>
            </a:xfrm>
            <a:prstGeom prst="rect">
              <a:avLst/>
            </a:prstGeom>
          </p:spPr>
        </p:pic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3304134D-9C66-5FBA-5799-FC0DDBBA7A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4740" r="29392"/>
            <a:stretch/>
          </p:blipFill>
          <p:spPr>
            <a:xfrm>
              <a:off x="1892288" y="6603653"/>
              <a:ext cx="2964993" cy="2063695"/>
            </a:xfrm>
            <a:prstGeom prst="rect">
              <a:avLst/>
            </a:prstGeom>
          </p:spPr>
        </p:pic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82B48DB5-5720-1D29-3CC8-CF18838DCCBE}"/>
                </a:ext>
              </a:extLst>
            </p:cNvPr>
            <p:cNvSpPr/>
            <p:nvPr/>
          </p:nvSpPr>
          <p:spPr>
            <a:xfrm>
              <a:off x="514350" y="4622591"/>
              <a:ext cx="5829300" cy="48776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6C40D25B-5920-80E4-AF59-27BCF7885C2E}"/>
                </a:ext>
              </a:extLst>
            </p:cNvPr>
            <p:cNvSpPr txBox="1"/>
            <p:nvPr/>
          </p:nvSpPr>
          <p:spPr>
            <a:xfrm>
              <a:off x="514350" y="4179470"/>
              <a:ext cx="35588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Full unedited gel for Figure2A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0D7A0346-6D51-577D-CBA7-83A49EE4C764}"/>
                </a:ext>
              </a:extLst>
            </p:cNvPr>
            <p:cNvSpPr txBox="1"/>
            <p:nvPr/>
          </p:nvSpPr>
          <p:spPr>
            <a:xfrm>
              <a:off x="666749" y="4698970"/>
              <a:ext cx="39312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C4AA9FCD-F727-511F-512D-9D49B1AE51D3}"/>
                </a:ext>
              </a:extLst>
            </p:cNvPr>
            <p:cNvSpPr txBox="1"/>
            <p:nvPr/>
          </p:nvSpPr>
          <p:spPr>
            <a:xfrm>
              <a:off x="3013343" y="8196581"/>
              <a:ext cx="8313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55CDBFEC-41CD-3920-3855-C82FE285EC36}"/>
                </a:ext>
              </a:extLst>
            </p:cNvPr>
            <p:cNvSpPr txBox="1"/>
            <p:nvPr/>
          </p:nvSpPr>
          <p:spPr>
            <a:xfrm>
              <a:off x="3102688" y="6424534"/>
              <a:ext cx="8631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ANP</a:t>
              </a:r>
              <a:endParaRPr lang="zh-CN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A6AE0F5A-2B11-0FF8-7778-4C0C281F8B12}"/>
                </a:ext>
              </a:extLst>
            </p:cNvPr>
            <p:cNvSpPr txBox="1"/>
            <p:nvPr/>
          </p:nvSpPr>
          <p:spPr>
            <a:xfrm>
              <a:off x="2892622" y="4723675"/>
              <a:ext cx="10731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ATP6V0A2</a:t>
              </a:r>
              <a:endParaRPr lang="zh-CN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箭头: 右 2">
              <a:extLst>
                <a:ext uri="{FF2B5EF4-FFF2-40B4-BE49-F238E27FC236}">
                  <a16:creationId xmlns:a16="http://schemas.microsoft.com/office/drawing/2014/main" id="{C779AC82-3A76-3458-A4A0-BBAF267DD5A2}"/>
                </a:ext>
              </a:extLst>
            </p:cNvPr>
            <p:cNvSpPr/>
            <p:nvPr/>
          </p:nvSpPr>
          <p:spPr>
            <a:xfrm flipH="1">
              <a:off x="4741235" y="5630339"/>
              <a:ext cx="341168" cy="164381"/>
            </a:xfrm>
            <a:prstGeom prst="right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tx1"/>
                </a:solidFill>
              </a:endParaRPr>
            </a:p>
          </p:txBody>
        </p:sp>
        <p:sp>
          <p:nvSpPr>
            <p:cNvPr id="7" name="箭头: 右 6">
              <a:extLst>
                <a:ext uri="{FF2B5EF4-FFF2-40B4-BE49-F238E27FC236}">
                  <a16:creationId xmlns:a16="http://schemas.microsoft.com/office/drawing/2014/main" id="{2705CBAA-E655-5A6A-AC1E-290E093FBD79}"/>
                </a:ext>
              </a:extLst>
            </p:cNvPr>
            <p:cNvSpPr/>
            <p:nvPr/>
          </p:nvSpPr>
          <p:spPr>
            <a:xfrm flipH="1">
              <a:off x="4770034" y="7299870"/>
              <a:ext cx="341168" cy="164381"/>
            </a:xfrm>
            <a:prstGeom prst="right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tx1"/>
                </a:solidFill>
              </a:endParaRPr>
            </a:p>
          </p:txBody>
        </p:sp>
        <p:sp>
          <p:nvSpPr>
            <p:cNvPr id="21" name="箭头: 右 20">
              <a:extLst>
                <a:ext uri="{FF2B5EF4-FFF2-40B4-BE49-F238E27FC236}">
                  <a16:creationId xmlns:a16="http://schemas.microsoft.com/office/drawing/2014/main" id="{1A888E54-490A-2268-F2A5-C1949656DC46}"/>
                </a:ext>
              </a:extLst>
            </p:cNvPr>
            <p:cNvSpPr/>
            <p:nvPr/>
          </p:nvSpPr>
          <p:spPr>
            <a:xfrm flipH="1">
              <a:off x="4895702" y="8887210"/>
              <a:ext cx="341168" cy="164381"/>
            </a:xfrm>
            <a:prstGeom prst="right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tx1"/>
                </a:solidFill>
              </a:endParaRPr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B93405C0-EBA3-4BDF-E022-4C6450E14A1E}"/>
                </a:ext>
              </a:extLst>
            </p:cNvPr>
            <p:cNvSpPr/>
            <p:nvPr/>
          </p:nvSpPr>
          <p:spPr>
            <a:xfrm>
              <a:off x="2631029" y="5582408"/>
              <a:ext cx="1923505" cy="27429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1" name="箭头: 右 10">
            <a:extLst>
              <a:ext uri="{FF2B5EF4-FFF2-40B4-BE49-F238E27FC236}">
                <a16:creationId xmlns:a16="http://schemas.microsoft.com/office/drawing/2014/main" id="{0BFB5891-BA2C-EEC6-D584-9E0EB4FBB053}"/>
              </a:ext>
            </a:extLst>
          </p:cNvPr>
          <p:cNvSpPr/>
          <p:nvPr/>
        </p:nvSpPr>
        <p:spPr>
          <a:xfrm flipH="1">
            <a:off x="4772749" y="2313579"/>
            <a:ext cx="341168" cy="164381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252378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图片 29">
            <a:extLst>
              <a:ext uri="{FF2B5EF4-FFF2-40B4-BE49-F238E27FC236}">
                <a16:creationId xmlns:a16="http://schemas.microsoft.com/office/drawing/2014/main" id="{4BE8354D-42D3-D04C-A880-7D77E6CFA5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7717" y="5983546"/>
            <a:ext cx="4742773" cy="1115430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6EE9C807-F944-7027-D42E-DED067DD9BC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439" r="20530"/>
          <a:stretch/>
        </p:blipFill>
        <p:spPr>
          <a:xfrm>
            <a:off x="997330" y="1711313"/>
            <a:ext cx="4380361" cy="132000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6C40D25B-5920-80E4-AF59-27BCF7885C2E}"/>
              </a:ext>
            </a:extLst>
          </p:cNvPr>
          <p:cNvSpPr txBox="1"/>
          <p:nvPr/>
        </p:nvSpPr>
        <p:spPr>
          <a:xfrm>
            <a:off x="514350" y="630383"/>
            <a:ext cx="3579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Full unedited gel for Figure3B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03528C52-6077-C9F6-06E7-90B034A2CDA0}"/>
              </a:ext>
            </a:extLst>
          </p:cNvPr>
          <p:cNvSpPr/>
          <p:nvPr/>
        </p:nvSpPr>
        <p:spPr>
          <a:xfrm>
            <a:off x="514350" y="1163783"/>
            <a:ext cx="5829300" cy="79802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8DC0A0AF-5122-01F5-15A6-1A1AB0FEE995}"/>
              </a:ext>
            </a:extLst>
          </p:cNvPr>
          <p:cNvSpPr txBox="1"/>
          <p:nvPr/>
        </p:nvSpPr>
        <p:spPr>
          <a:xfrm>
            <a:off x="2877449" y="1227223"/>
            <a:ext cx="13005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TP6V0A2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DD7B7AF-2731-24BE-6C3D-C9B5ECED565D}"/>
              </a:ext>
            </a:extLst>
          </p:cNvPr>
          <p:cNvSpPr txBox="1"/>
          <p:nvPr/>
        </p:nvSpPr>
        <p:spPr>
          <a:xfrm>
            <a:off x="3075800" y="5502361"/>
            <a:ext cx="903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40559F4-865D-BC50-6ADE-78AFAF4FAA95}"/>
              </a:ext>
            </a:extLst>
          </p:cNvPr>
          <p:cNvSpPr txBox="1"/>
          <p:nvPr/>
        </p:nvSpPr>
        <p:spPr>
          <a:xfrm>
            <a:off x="666749" y="1227223"/>
            <a:ext cx="4797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BAF9E01A-0774-5A73-2C74-A756A972AC60}"/>
              </a:ext>
            </a:extLst>
          </p:cNvPr>
          <p:cNvSpPr txBox="1"/>
          <p:nvPr/>
        </p:nvSpPr>
        <p:spPr>
          <a:xfrm>
            <a:off x="3141153" y="3195386"/>
            <a:ext cx="5756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NP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0D3C2C69-BC4E-9793-C33F-729167F0916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9780" y="3487420"/>
            <a:ext cx="4742773" cy="1944625"/>
          </a:xfrm>
          <a:prstGeom prst="rect">
            <a:avLst/>
          </a:prstGeom>
        </p:spPr>
      </p:pic>
      <p:sp>
        <p:nvSpPr>
          <p:cNvPr id="3" name="箭头: 右 2">
            <a:extLst>
              <a:ext uri="{FF2B5EF4-FFF2-40B4-BE49-F238E27FC236}">
                <a16:creationId xmlns:a16="http://schemas.microsoft.com/office/drawing/2014/main" id="{2107D16C-62A5-D68D-B553-C8894620347B}"/>
              </a:ext>
            </a:extLst>
          </p:cNvPr>
          <p:cNvSpPr/>
          <p:nvPr/>
        </p:nvSpPr>
        <p:spPr>
          <a:xfrm flipH="1">
            <a:off x="5479906" y="2576989"/>
            <a:ext cx="341168" cy="164381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8" name="箭头: 右 7">
            <a:extLst>
              <a:ext uri="{FF2B5EF4-FFF2-40B4-BE49-F238E27FC236}">
                <a16:creationId xmlns:a16="http://schemas.microsoft.com/office/drawing/2014/main" id="{FF63084A-CD11-A93A-9223-754946BC75F7}"/>
              </a:ext>
            </a:extLst>
          </p:cNvPr>
          <p:cNvSpPr/>
          <p:nvPr/>
        </p:nvSpPr>
        <p:spPr>
          <a:xfrm flipH="1">
            <a:off x="5479906" y="4132006"/>
            <a:ext cx="341168" cy="164381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9" name="箭头: 右 8">
            <a:extLst>
              <a:ext uri="{FF2B5EF4-FFF2-40B4-BE49-F238E27FC236}">
                <a16:creationId xmlns:a16="http://schemas.microsoft.com/office/drawing/2014/main" id="{493390F0-F216-2737-D8BD-8104F9497523}"/>
              </a:ext>
            </a:extLst>
          </p:cNvPr>
          <p:cNvSpPr/>
          <p:nvPr/>
        </p:nvSpPr>
        <p:spPr>
          <a:xfrm flipH="1">
            <a:off x="5642553" y="6290176"/>
            <a:ext cx="341168" cy="164381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573866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图片 20">
            <a:extLst>
              <a:ext uri="{FF2B5EF4-FFF2-40B4-BE49-F238E27FC236}">
                <a16:creationId xmlns:a16="http://schemas.microsoft.com/office/drawing/2014/main" id="{F86CABC1-A617-380F-CB4D-490C506CA7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6508" y="1440242"/>
            <a:ext cx="3237953" cy="1841949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6C40D25B-5920-80E4-AF59-27BCF7885C2E}"/>
              </a:ext>
            </a:extLst>
          </p:cNvPr>
          <p:cNvSpPr txBox="1"/>
          <p:nvPr/>
        </p:nvSpPr>
        <p:spPr>
          <a:xfrm>
            <a:off x="514350" y="630383"/>
            <a:ext cx="3829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Full unedited gel for Figure4E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03528C52-6077-C9F6-06E7-90B034A2CDA0}"/>
              </a:ext>
            </a:extLst>
          </p:cNvPr>
          <p:cNvSpPr/>
          <p:nvPr/>
        </p:nvSpPr>
        <p:spPr>
          <a:xfrm>
            <a:off x="514350" y="1163783"/>
            <a:ext cx="5829300" cy="79802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ECE89BA-5B14-26E2-57A9-AA75C373FB19}"/>
              </a:ext>
            </a:extLst>
          </p:cNvPr>
          <p:cNvSpPr txBox="1"/>
          <p:nvPr/>
        </p:nvSpPr>
        <p:spPr>
          <a:xfrm>
            <a:off x="666749" y="1227223"/>
            <a:ext cx="4797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5CFE6A7-BCBC-E129-E320-295D18FE1F23}"/>
              </a:ext>
            </a:extLst>
          </p:cNvPr>
          <p:cNvSpPr txBox="1"/>
          <p:nvPr/>
        </p:nvSpPr>
        <p:spPr>
          <a:xfrm>
            <a:off x="3013539" y="7141321"/>
            <a:ext cx="903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31F6AB32-BC55-934F-5B50-893016F69C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1193" y="7613166"/>
            <a:ext cx="2815614" cy="1468514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D8867CF3-8B4D-BD7D-2742-067F5768580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61118" y="3305103"/>
            <a:ext cx="3177753" cy="3623991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4CA5C13B-ED78-92FD-BA28-B3F19F19C5EA}"/>
              </a:ext>
            </a:extLst>
          </p:cNvPr>
          <p:cNvSpPr txBox="1"/>
          <p:nvPr/>
        </p:nvSpPr>
        <p:spPr>
          <a:xfrm>
            <a:off x="3064481" y="3305103"/>
            <a:ext cx="7290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NOX1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DF7B6D1-5370-2194-5A2C-F0F7A6F1A98F}"/>
              </a:ext>
            </a:extLst>
          </p:cNvPr>
          <p:cNvSpPr txBox="1"/>
          <p:nvPr/>
        </p:nvSpPr>
        <p:spPr>
          <a:xfrm>
            <a:off x="2977054" y="1443663"/>
            <a:ext cx="903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PTGS2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箭头: 右 14">
            <a:extLst>
              <a:ext uri="{FF2B5EF4-FFF2-40B4-BE49-F238E27FC236}">
                <a16:creationId xmlns:a16="http://schemas.microsoft.com/office/drawing/2014/main" id="{B01FFED4-F930-A276-5DC3-558A91CA8651}"/>
              </a:ext>
            </a:extLst>
          </p:cNvPr>
          <p:cNvSpPr/>
          <p:nvPr/>
        </p:nvSpPr>
        <p:spPr>
          <a:xfrm flipH="1">
            <a:off x="5073556" y="2501060"/>
            <a:ext cx="341168" cy="164381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16" name="箭头: 右 15">
            <a:extLst>
              <a:ext uri="{FF2B5EF4-FFF2-40B4-BE49-F238E27FC236}">
                <a16:creationId xmlns:a16="http://schemas.microsoft.com/office/drawing/2014/main" id="{735FC472-118F-4301-66FD-6CF4CCB540AF}"/>
              </a:ext>
            </a:extLst>
          </p:cNvPr>
          <p:cNvSpPr/>
          <p:nvPr/>
        </p:nvSpPr>
        <p:spPr>
          <a:xfrm flipH="1">
            <a:off x="5163058" y="4677938"/>
            <a:ext cx="341168" cy="164381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17" name="箭头: 右 16">
            <a:extLst>
              <a:ext uri="{FF2B5EF4-FFF2-40B4-BE49-F238E27FC236}">
                <a16:creationId xmlns:a16="http://schemas.microsoft.com/office/drawing/2014/main" id="{8F38206C-87FE-DE99-CF35-2DA2CF9509BD}"/>
              </a:ext>
            </a:extLst>
          </p:cNvPr>
          <p:cNvSpPr/>
          <p:nvPr/>
        </p:nvSpPr>
        <p:spPr>
          <a:xfrm flipH="1">
            <a:off x="5031082" y="7954357"/>
            <a:ext cx="341168" cy="164381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001550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F04475D2-6134-06C4-3B88-3B8EE39522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8869" y="3525186"/>
            <a:ext cx="3309876" cy="1574536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04BF3B71-7499-CA64-7AC1-3D19DC9B5F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0460" y="1468195"/>
            <a:ext cx="4538686" cy="1839543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6C40D25B-5920-80E4-AF59-27BCF7885C2E}"/>
              </a:ext>
            </a:extLst>
          </p:cNvPr>
          <p:cNvSpPr txBox="1"/>
          <p:nvPr/>
        </p:nvSpPr>
        <p:spPr>
          <a:xfrm>
            <a:off x="514349" y="630383"/>
            <a:ext cx="3551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Full unedited gel for Figure5C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E2C37DF-BE91-8BB0-5831-111C96A912D6}"/>
              </a:ext>
            </a:extLst>
          </p:cNvPr>
          <p:cNvSpPr txBox="1"/>
          <p:nvPr/>
        </p:nvSpPr>
        <p:spPr>
          <a:xfrm>
            <a:off x="3241934" y="7526273"/>
            <a:ext cx="903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12832BA-3B26-AAD8-97B1-C8E2448F4080}"/>
              </a:ext>
            </a:extLst>
          </p:cNvPr>
          <p:cNvSpPr txBox="1"/>
          <p:nvPr/>
        </p:nvSpPr>
        <p:spPr>
          <a:xfrm>
            <a:off x="2996850" y="3458261"/>
            <a:ext cx="7290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NOX1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210C915-3726-CA19-9E4D-AE4C8EE903A8}"/>
              </a:ext>
            </a:extLst>
          </p:cNvPr>
          <p:cNvSpPr txBox="1"/>
          <p:nvPr/>
        </p:nvSpPr>
        <p:spPr>
          <a:xfrm>
            <a:off x="2977054" y="1163783"/>
            <a:ext cx="903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PTGS2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箭头: 右 10">
            <a:extLst>
              <a:ext uri="{FF2B5EF4-FFF2-40B4-BE49-F238E27FC236}">
                <a16:creationId xmlns:a16="http://schemas.microsoft.com/office/drawing/2014/main" id="{9C1B867B-A3C6-74BB-DCDD-CA1F1FCA9659}"/>
              </a:ext>
            </a:extLst>
          </p:cNvPr>
          <p:cNvSpPr/>
          <p:nvPr/>
        </p:nvSpPr>
        <p:spPr>
          <a:xfrm flipH="1">
            <a:off x="5162416" y="2472984"/>
            <a:ext cx="341168" cy="164381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B247485-2C91-41AC-CCBA-D0021F9F275E}"/>
              </a:ext>
            </a:extLst>
          </p:cNvPr>
          <p:cNvSpPr txBox="1"/>
          <p:nvPr/>
        </p:nvSpPr>
        <p:spPr>
          <a:xfrm>
            <a:off x="666749" y="1227223"/>
            <a:ext cx="4797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1AD3211C-4074-FC34-BF6E-89468088B97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80289" y="5454075"/>
            <a:ext cx="3897422" cy="2163616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AAE0E6AA-A65B-714F-9EB8-98EFBF8C6199}"/>
              </a:ext>
            </a:extLst>
          </p:cNvPr>
          <p:cNvSpPr txBox="1"/>
          <p:nvPr/>
        </p:nvSpPr>
        <p:spPr>
          <a:xfrm>
            <a:off x="3302236" y="5099722"/>
            <a:ext cx="7290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GPX4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A16CD265-FE8D-CAC5-26F1-A68F7D63FBD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19782"/>
          <a:stretch/>
        </p:blipFill>
        <p:spPr>
          <a:xfrm>
            <a:off x="1528060" y="7664267"/>
            <a:ext cx="4395654" cy="1368897"/>
          </a:xfrm>
          <a:prstGeom prst="rect">
            <a:avLst/>
          </a:prstGeom>
        </p:spPr>
      </p:pic>
      <p:sp>
        <p:nvSpPr>
          <p:cNvPr id="19" name="箭头: 右 18">
            <a:extLst>
              <a:ext uri="{FF2B5EF4-FFF2-40B4-BE49-F238E27FC236}">
                <a16:creationId xmlns:a16="http://schemas.microsoft.com/office/drawing/2014/main" id="{0513BEC2-1386-EA11-F4A0-457F846BF2DB}"/>
              </a:ext>
            </a:extLst>
          </p:cNvPr>
          <p:cNvSpPr/>
          <p:nvPr/>
        </p:nvSpPr>
        <p:spPr>
          <a:xfrm flipH="1">
            <a:off x="5162416" y="4191733"/>
            <a:ext cx="341168" cy="164381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03528C52-6077-C9F6-06E7-90B034A2CDA0}"/>
              </a:ext>
            </a:extLst>
          </p:cNvPr>
          <p:cNvSpPr/>
          <p:nvPr/>
        </p:nvSpPr>
        <p:spPr>
          <a:xfrm>
            <a:off x="514350" y="1163783"/>
            <a:ext cx="5829300" cy="79802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箭头: 右 14">
            <a:extLst>
              <a:ext uri="{FF2B5EF4-FFF2-40B4-BE49-F238E27FC236}">
                <a16:creationId xmlns:a16="http://schemas.microsoft.com/office/drawing/2014/main" id="{704D50D2-AA0F-11E8-1663-2A5AD87EE29D}"/>
              </a:ext>
            </a:extLst>
          </p:cNvPr>
          <p:cNvSpPr/>
          <p:nvPr/>
        </p:nvSpPr>
        <p:spPr>
          <a:xfrm flipH="1">
            <a:off x="5207127" y="8298655"/>
            <a:ext cx="341168" cy="164381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13" name="箭头: 右 12">
            <a:extLst>
              <a:ext uri="{FF2B5EF4-FFF2-40B4-BE49-F238E27FC236}">
                <a16:creationId xmlns:a16="http://schemas.microsoft.com/office/drawing/2014/main" id="{B71654A4-192D-7893-EF4F-010F6A88BAA7}"/>
              </a:ext>
            </a:extLst>
          </p:cNvPr>
          <p:cNvSpPr/>
          <p:nvPr/>
        </p:nvSpPr>
        <p:spPr>
          <a:xfrm flipH="1">
            <a:off x="5162416" y="6742642"/>
            <a:ext cx="341168" cy="164381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879531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>
            <a:extLst>
              <a:ext uri="{FF2B5EF4-FFF2-40B4-BE49-F238E27FC236}">
                <a16:creationId xmlns:a16="http://schemas.microsoft.com/office/drawing/2014/main" id="{51F504C5-28E4-7675-2A7C-C9ADB30AF1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2424" y="5942465"/>
            <a:ext cx="5582429" cy="1371791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3292D82C-C44F-5926-5516-9154AED014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4972" y="3631288"/>
            <a:ext cx="5553850" cy="1876687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8289E811-43F5-0A39-A4AC-1114F1704E9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4349" y="1604483"/>
            <a:ext cx="5829515" cy="1409633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6C40D25B-5920-80E4-AF59-27BCF7885C2E}"/>
              </a:ext>
            </a:extLst>
          </p:cNvPr>
          <p:cNvSpPr txBox="1"/>
          <p:nvPr/>
        </p:nvSpPr>
        <p:spPr>
          <a:xfrm>
            <a:off x="514349" y="630383"/>
            <a:ext cx="3461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Full unedited gel for Figure5L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03528C52-6077-C9F6-06E7-90B034A2CDA0}"/>
              </a:ext>
            </a:extLst>
          </p:cNvPr>
          <p:cNvSpPr/>
          <p:nvPr/>
        </p:nvSpPr>
        <p:spPr>
          <a:xfrm>
            <a:off x="514350" y="1163783"/>
            <a:ext cx="5829300" cy="79802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C15BD88-267F-04E1-42E4-873BB37DFC01}"/>
              </a:ext>
            </a:extLst>
          </p:cNvPr>
          <p:cNvSpPr txBox="1"/>
          <p:nvPr/>
        </p:nvSpPr>
        <p:spPr>
          <a:xfrm>
            <a:off x="3046821" y="5634688"/>
            <a:ext cx="903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3BE47A1-C51B-A1BC-0639-EE7E3E40D5B4}"/>
              </a:ext>
            </a:extLst>
          </p:cNvPr>
          <p:cNvSpPr txBox="1"/>
          <p:nvPr/>
        </p:nvSpPr>
        <p:spPr>
          <a:xfrm>
            <a:off x="3093639" y="3231029"/>
            <a:ext cx="6707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NOX1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80333916-C384-28F2-321D-5895374DDEA6}"/>
              </a:ext>
            </a:extLst>
          </p:cNvPr>
          <p:cNvSpPr txBox="1"/>
          <p:nvPr/>
        </p:nvSpPr>
        <p:spPr>
          <a:xfrm>
            <a:off x="2977054" y="1296706"/>
            <a:ext cx="903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PTGS2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箭头: 右 8">
            <a:extLst>
              <a:ext uri="{FF2B5EF4-FFF2-40B4-BE49-F238E27FC236}">
                <a16:creationId xmlns:a16="http://schemas.microsoft.com/office/drawing/2014/main" id="{4C47FA5F-FA9E-FDCD-ED3A-702FEDA0A109}"/>
              </a:ext>
            </a:extLst>
          </p:cNvPr>
          <p:cNvSpPr/>
          <p:nvPr/>
        </p:nvSpPr>
        <p:spPr>
          <a:xfrm flipH="1">
            <a:off x="5194307" y="2333261"/>
            <a:ext cx="341168" cy="164381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10" name="箭头: 右 9">
            <a:extLst>
              <a:ext uri="{FF2B5EF4-FFF2-40B4-BE49-F238E27FC236}">
                <a16:creationId xmlns:a16="http://schemas.microsoft.com/office/drawing/2014/main" id="{68A5A6EB-7335-C729-AD61-6CBA3052ACBA}"/>
              </a:ext>
            </a:extLst>
          </p:cNvPr>
          <p:cNvSpPr/>
          <p:nvPr/>
        </p:nvSpPr>
        <p:spPr>
          <a:xfrm flipH="1">
            <a:off x="5535475" y="4728220"/>
            <a:ext cx="341168" cy="164381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11" name="箭头: 右 10">
            <a:extLst>
              <a:ext uri="{FF2B5EF4-FFF2-40B4-BE49-F238E27FC236}">
                <a16:creationId xmlns:a16="http://schemas.microsoft.com/office/drawing/2014/main" id="{3F1DACA9-70ED-A06A-367F-417F64CF9B03}"/>
              </a:ext>
            </a:extLst>
          </p:cNvPr>
          <p:cNvSpPr/>
          <p:nvPr/>
        </p:nvSpPr>
        <p:spPr>
          <a:xfrm flipH="1">
            <a:off x="5602499" y="6440526"/>
            <a:ext cx="341168" cy="164381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95AFBE9D-DFA5-FB8B-74BA-6661C95322F5}"/>
              </a:ext>
            </a:extLst>
          </p:cNvPr>
          <p:cNvSpPr txBox="1"/>
          <p:nvPr/>
        </p:nvSpPr>
        <p:spPr>
          <a:xfrm>
            <a:off x="666749" y="1227223"/>
            <a:ext cx="4797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91449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>
            <a:extLst>
              <a:ext uri="{FF2B5EF4-FFF2-40B4-BE49-F238E27FC236}">
                <a16:creationId xmlns:a16="http://schemas.microsoft.com/office/drawing/2014/main" id="{6B6DF892-7B49-687A-1212-D46F332C8DB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0785"/>
          <a:stretch/>
        </p:blipFill>
        <p:spPr>
          <a:xfrm>
            <a:off x="1554523" y="6137397"/>
            <a:ext cx="3748954" cy="1615274"/>
          </a:xfrm>
          <a:prstGeom prst="rect">
            <a:avLst/>
          </a:prstGeom>
        </p:spPr>
      </p:pic>
      <p:grpSp>
        <p:nvGrpSpPr>
          <p:cNvPr id="22" name="组合 21">
            <a:extLst>
              <a:ext uri="{FF2B5EF4-FFF2-40B4-BE49-F238E27FC236}">
                <a16:creationId xmlns:a16="http://schemas.microsoft.com/office/drawing/2014/main" id="{2FCF69A1-19C8-0CB3-6FBB-83A518E3203B}"/>
              </a:ext>
            </a:extLst>
          </p:cNvPr>
          <p:cNvGrpSpPr/>
          <p:nvPr/>
        </p:nvGrpSpPr>
        <p:grpSpPr>
          <a:xfrm>
            <a:off x="573934" y="1350306"/>
            <a:ext cx="4833950" cy="2316324"/>
            <a:chOff x="573934" y="1350306"/>
            <a:chExt cx="4833950" cy="2316324"/>
          </a:xfrm>
        </p:grpSpPr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038157F5-F16D-E6D7-274C-2599798BE74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73934" y="1625066"/>
              <a:ext cx="4833950" cy="2041564"/>
            </a:xfrm>
            <a:prstGeom prst="rect">
              <a:avLst/>
            </a:prstGeom>
          </p:spPr>
        </p:pic>
        <p:sp>
          <p:nvSpPr>
            <p:cNvPr id="6" name="箭头: 右 5">
              <a:extLst>
                <a:ext uri="{FF2B5EF4-FFF2-40B4-BE49-F238E27FC236}">
                  <a16:creationId xmlns:a16="http://schemas.microsoft.com/office/drawing/2014/main" id="{F85843D5-9482-53F6-05B6-F693AD295680}"/>
                </a:ext>
              </a:extLst>
            </p:cNvPr>
            <p:cNvSpPr/>
            <p:nvPr/>
          </p:nvSpPr>
          <p:spPr>
            <a:xfrm flipH="1">
              <a:off x="4857902" y="2570366"/>
              <a:ext cx="341168" cy="164381"/>
            </a:xfrm>
            <a:prstGeom prst="right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tx1"/>
                </a:solidFill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87887654-FBE0-CA75-AF1C-42560B3E8B5D}"/>
                </a:ext>
              </a:extLst>
            </p:cNvPr>
            <p:cNvSpPr txBox="1"/>
            <p:nvPr/>
          </p:nvSpPr>
          <p:spPr>
            <a:xfrm>
              <a:off x="3034191" y="1350306"/>
              <a:ext cx="7896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LAMP2</a:t>
              </a:r>
              <a:endParaRPr lang="zh-CN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文本框 3">
            <a:extLst>
              <a:ext uri="{FF2B5EF4-FFF2-40B4-BE49-F238E27FC236}">
                <a16:creationId xmlns:a16="http://schemas.microsoft.com/office/drawing/2014/main" id="{6C40D25B-5920-80E4-AF59-27BCF7885C2E}"/>
              </a:ext>
            </a:extLst>
          </p:cNvPr>
          <p:cNvSpPr txBox="1"/>
          <p:nvPr/>
        </p:nvSpPr>
        <p:spPr>
          <a:xfrm>
            <a:off x="514350" y="630383"/>
            <a:ext cx="34896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Full unedited gel for Figure6B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03528C52-6077-C9F6-06E7-90B034A2CDA0}"/>
              </a:ext>
            </a:extLst>
          </p:cNvPr>
          <p:cNvSpPr/>
          <p:nvPr/>
        </p:nvSpPr>
        <p:spPr>
          <a:xfrm>
            <a:off x="514350" y="1163783"/>
            <a:ext cx="5829300" cy="79802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8D210EC7-D948-31D4-A0CE-C8B6C43BDC6D}"/>
              </a:ext>
            </a:extLst>
          </p:cNvPr>
          <p:cNvGrpSpPr/>
          <p:nvPr/>
        </p:nvGrpSpPr>
        <p:grpSpPr>
          <a:xfrm>
            <a:off x="1571498" y="3554670"/>
            <a:ext cx="3657165" cy="2806671"/>
            <a:chOff x="1571498" y="3554670"/>
            <a:chExt cx="3657165" cy="2806671"/>
          </a:xfrm>
        </p:grpSpPr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28B31E02-AEF3-B456-B3DD-782204EC4B1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571498" y="4075127"/>
              <a:ext cx="3627572" cy="2286214"/>
            </a:xfrm>
            <a:prstGeom prst="rect">
              <a:avLst/>
            </a:prstGeom>
          </p:spPr>
        </p:pic>
        <p:sp>
          <p:nvSpPr>
            <p:cNvPr id="7" name="箭头: 右 6">
              <a:extLst>
                <a:ext uri="{FF2B5EF4-FFF2-40B4-BE49-F238E27FC236}">
                  <a16:creationId xmlns:a16="http://schemas.microsoft.com/office/drawing/2014/main" id="{A5A28368-1003-9A7F-030C-E234A2E1BE41}"/>
                </a:ext>
              </a:extLst>
            </p:cNvPr>
            <p:cNvSpPr/>
            <p:nvPr/>
          </p:nvSpPr>
          <p:spPr>
            <a:xfrm flipH="1">
              <a:off x="4887495" y="4900287"/>
              <a:ext cx="341168" cy="164381"/>
            </a:xfrm>
            <a:prstGeom prst="right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tx1"/>
                </a:solidFill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5911B47B-00EA-F874-3B0B-269880437984}"/>
                </a:ext>
              </a:extLst>
            </p:cNvPr>
            <p:cNvSpPr txBox="1"/>
            <p:nvPr/>
          </p:nvSpPr>
          <p:spPr>
            <a:xfrm>
              <a:off x="2746709" y="3554670"/>
              <a:ext cx="13645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CathepsinB</a:t>
              </a:r>
              <a:endParaRPr lang="zh-CN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文本框 11">
            <a:extLst>
              <a:ext uri="{FF2B5EF4-FFF2-40B4-BE49-F238E27FC236}">
                <a16:creationId xmlns:a16="http://schemas.microsoft.com/office/drawing/2014/main" id="{8FBA6BA9-39FC-3ECC-CAF9-7009DB6C3B93}"/>
              </a:ext>
            </a:extLst>
          </p:cNvPr>
          <p:cNvSpPr txBox="1"/>
          <p:nvPr/>
        </p:nvSpPr>
        <p:spPr>
          <a:xfrm>
            <a:off x="666749" y="1227223"/>
            <a:ext cx="4797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箭头: 右 7">
            <a:extLst>
              <a:ext uri="{FF2B5EF4-FFF2-40B4-BE49-F238E27FC236}">
                <a16:creationId xmlns:a16="http://schemas.microsoft.com/office/drawing/2014/main" id="{C16F737F-5AA1-3C80-90A3-13C8E4AA90AA}"/>
              </a:ext>
            </a:extLst>
          </p:cNvPr>
          <p:cNvSpPr/>
          <p:nvPr/>
        </p:nvSpPr>
        <p:spPr>
          <a:xfrm flipH="1">
            <a:off x="4928900" y="6784912"/>
            <a:ext cx="341168" cy="164381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85F605D-1E59-521B-DE49-EA0C7D483FC7}"/>
              </a:ext>
            </a:extLst>
          </p:cNvPr>
          <p:cNvSpPr txBox="1"/>
          <p:nvPr/>
        </p:nvSpPr>
        <p:spPr>
          <a:xfrm>
            <a:off x="3147637" y="5563217"/>
            <a:ext cx="903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56015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>
            <a:extLst>
              <a:ext uri="{FF2B5EF4-FFF2-40B4-BE49-F238E27FC236}">
                <a16:creationId xmlns:a16="http://schemas.microsoft.com/office/drawing/2014/main" id="{87887654-FBE0-CA75-AF1C-42560B3E8B5D}"/>
              </a:ext>
            </a:extLst>
          </p:cNvPr>
          <p:cNvSpPr txBox="1"/>
          <p:nvPr/>
        </p:nvSpPr>
        <p:spPr>
          <a:xfrm>
            <a:off x="3034191" y="1350306"/>
            <a:ext cx="7896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LAMP2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6C40D25B-5920-80E4-AF59-27BCF7885C2E}"/>
              </a:ext>
            </a:extLst>
          </p:cNvPr>
          <p:cNvSpPr txBox="1"/>
          <p:nvPr/>
        </p:nvSpPr>
        <p:spPr>
          <a:xfrm>
            <a:off x="514350" y="630383"/>
            <a:ext cx="34896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Full unedited gel for Figure6E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03528C52-6077-C9F6-06E7-90B034A2CDA0}"/>
              </a:ext>
            </a:extLst>
          </p:cNvPr>
          <p:cNvSpPr/>
          <p:nvPr/>
        </p:nvSpPr>
        <p:spPr>
          <a:xfrm>
            <a:off x="514350" y="1163783"/>
            <a:ext cx="5829300" cy="79802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8FBA6BA9-39FC-3ECC-CAF9-7009DB6C3B93}"/>
              </a:ext>
            </a:extLst>
          </p:cNvPr>
          <p:cNvSpPr txBox="1"/>
          <p:nvPr/>
        </p:nvSpPr>
        <p:spPr>
          <a:xfrm>
            <a:off x="666749" y="1227223"/>
            <a:ext cx="4797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3C12E2E3-8F27-825B-8EFB-EDDE0AC6100F}"/>
              </a:ext>
            </a:extLst>
          </p:cNvPr>
          <p:cNvGrpSpPr/>
          <p:nvPr/>
        </p:nvGrpSpPr>
        <p:grpSpPr>
          <a:xfrm>
            <a:off x="1100649" y="6439425"/>
            <a:ext cx="4782217" cy="1747190"/>
            <a:chOff x="1074783" y="6436636"/>
            <a:chExt cx="4782217" cy="1747190"/>
          </a:xfrm>
        </p:grpSpPr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EF68BBA2-3FD0-D124-53FA-BB5200CEDD6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74783" y="6440508"/>
              <a:ext cx="4782217" cy="1743318"/>
            </a:xfrm>
            <a:prstGeom prst="rect">
              <a:avLst/>
            </a:prstGeom>
          </p:spPr>
        </p:pic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185F605D-1E59-521B-DE49-EA0C7D483FC7}"/>
                </a:ext>
              </a:extLst>
            </p:cNvPr>
            <p:cNvSpPr txBox="1"/>
            <p:nvPr/>
          </p:nvSpPr>
          <p:spPr>
            <a:xfrm>
              <a:off x="2923828" y="6436636"/>
              <a:ext cx="9038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30B72385-90F0-F71D-0C48-DBFB611B4946}"/>
              </a:ext>
            </a:extLst>
          </p:cNvPr>
          <p:cNvGrpSpPr/>
          <p:nvPr/>
        </p:nvGrpSpPr>
        <p:grpSpPr>
          <a:xfrm>
            <a:off x="1146462" y="3722715"/>
            <a:ext cx="4833950" cy="2169846"/>
            <a:chOff x="1146462" y="3760034"/>
            <a:chExt cx="4833950" cy="2169846"/>
          </a:xfrm>
        </p:grpSpPr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07B71D23-7BE6-9640-7E3B-14B592A2168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46462" y="4188619"/>
              <a:ext cx="4833950" cy="1741261"/>
            </a:xfrm>
            <a:prstGeom prst="rect">
              <a:avLst/>
            </a:prstGeom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5911B47B-00EA-F874-3B0B-269880437984}"/>
                </a:ext>
              </a:extLst>
            </p:cNvPr>
            <p:cNvSpPr txBox="1"/>
            <p:nvPr/>
          </p:nvSpPr>
          <p:spPr>
            <a:xfrm>
              <a:off x="2746709" y="3760034"/>
              <a:ext cx="13645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CathepsinB</a:t>
              </a:r>
              <a:endParaRPr lang="zh-CN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矩形 25">
              <a:extLst>
                <a:ext uri="{FF2B5EF4-FFF2-40B4-BE49-F238E27FC236}">
                  <a16:creationId xmlns:a16="http://schemas.microsoft.com/office/drawing/2014/main" id="{ADBE5FCD-8DAE-8E21-4A88-FDE728B18BB2}"/>
                </a:ext>
              </a:extLst>
            </p:cNvPr>
            <p:cNvSpPr/>
            <p:nvPr/>
          </p:nvSpPr>
          <p:spPr>
            <a:xfrm>
              <a:off x="1869873" y="4536610"/>
              <a:ext cx="3841665" cy="41639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29" name="图片 28">
            <a:extLst>
              <a:ext uri="{FF2B5EF4-FFF2-40B4-BE49-F238E27FC236}">
                <a16:creationId xmlns:a16="http://schemas.microsoft.com/office/drawing/2014/main" id="{182F36DA-5799-968A-98E1-A5332463B97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490" t="8456" r="3529" b="8084"/>
          <a:stretch/>
        </p:blipFill>
        <p:spPr>
          <a:xfrm>
            <a:off x="906605" y="1719385"/>
            <a:ext cx="4990070" cy="1627631"/>
          </a:xfrm>
          <a:prstGeom prst="rect">
            <a:avLst/>
          </a:prstGeom>
        </p:spPr>
      </p:pic>
      <p:sp>
        <p:nvSpPr>
          <p:cNvPr id="31" name="矩形 30">
            <a:extLst>
              <a:ext uri="{FF2B5EF4-FFF2-40B4-BE49-F238E27FC236}">
                <a16:creationId xmlns:a16="http://schemas.microsoft.com/office/drawing/2014/main" id="{8E6ED3AD-2EE3-E141-3948-AD7DAA365D09}"/>
              </a:ext>
            </a:extLst>
          </p:cNvPr>
          <p:cNvSpPr/>
          <p:nvPr/>
        </p:nvSpPr>
        <p:spPr>
          <a:xfrm>
            <a:off x="1995054" y="2660138"/>
            <a:ext cx="3349726" cy="5220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箭头: 右 31">
            <a:extLst>
              <a:ext uri="{FF2B5EF4-FFF2-40B4-BE49-F238E27FC236}">
                <a16:creationId xmlns:a16="http://schemas.microsoft.com/office/drawing/2014/main" id="{980A0BA2-F101-2F96-B211-B2C63F0EDC36}"/>
              </a:ext>
            </a:extLst>
          </p:cNvPr>
          <p:cNvSpPr/>
          <p:nvPr/>
        </p:nvSpPr>
        <p:spPr>
          <a:xfrm flipH="1">
            <a:off x="5711538" y="7275081"/>
            <a:ext cx="341168" cy="164381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8945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65</TotalTime>
  <Words>72</Words>
  <Application>Microsoft Office PowerPoint</Application>
  <PresentationFormat>A4 纸张(210x297 毫米)</PresentationFormat>
  <Paragraphs>40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明明 张</dc:creator>
  <cp:lastModifiedBy>明明 张</cp:lastModifiedBy>
  <cp:revision>17</cp:revision>
  <dcterms:created xsi:type="dcterms:W3CDTF">2024-01-28T07:15:25Z</dcterms:created>
  <dcterms:modified xsi:type="dcterms:W3CDTF">2024-06-10T12:34:36Z</dcterms:modified>
</cp:coreProperties>
</file>